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2396F-F8AC-47F9-BB44-2C8618AC6F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4BFC3-04DB-40CB-B60E-00E4C88516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5D56B-D4AA-4778-B275-F1E837412F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95808-73BB-402A-9CDA-391677FC2B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71F6D-FDE1-47E9-B73B-6ECAD0EACA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CD779-26E0-4BFE-94B0-161672BEA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D29CC-687C-4295-9375-90F4267EBF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F4D64-39E7-4782-9548-2E04339150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5DDC3-920E-4A31-A498-B5EC06A52B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671D4-A46A-45D7-8494-B906A4D26C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EE991-1EDA-480C-B823-BDE6A19A06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B0DD0-1087-43AF-A4A0-210ED25CF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D85AE2-6B2D-49F5-9C83-7EB7A5DA1E0D}" type="datetime">
              <a:rPr b="0" lang="en-US" sz="1200" spc="-1" strike="noStrike">
                <a:solidFill>
                  <a:srgbClr val="898989"/>
                </a:solidFill>
                <a:latin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53F5B0-050B-4B78-BC89-C6DB10936051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320" y="1317600"/>
          <a:ext cx="8970840" cy="4303800"/>
        </p:xfrm>
        <a:graphic>
          <a:graphicData uri="http://schemas.openxmlformats.org/drawingml/2006/table">
            <a:tbl>
              <a:tblPr/>
              <a:tblGrid>
                <a:gridCol w="3103560"/>
                <a:gridCol w="3736800"/>
                <a:gridCol w="2130480"/>
              </a:tblGrid>
              <a:tr h="53820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sure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utcome specific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portanc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768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tic relatednes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70% aa identity to regional strains of selected subtyp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dato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116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geneity, integrity, identity, “antigenicity”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70% monomer in cell line; purified to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 90% homogeneity; binds sCD4; binds subtype specific sera &amp; HIV neut. Ab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dato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912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pression/secretion leve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P of &gt;1-2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/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s/day from stable CHO-cell li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dato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316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munogenicity: Env binding Ab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LISA  GMT &gt;10,00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dato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948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munogenicity: Neutralizing A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 500 ID</a:t>
                      </a:r>
                      <a:r>
                        <a:rPr b="0" lang="en-US" sz="14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titers vs. 2 Tier 1a strains; &gt; 100 vs. 2 Tier 1b; evidence of activity vs. Tier 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er 1 mandatory; Tier 2 recommend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912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munogenicity: Other Ab activiti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vidence of cross-strain/subtype binding activ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commend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5880">
                <a:tc>
                  <a:txBody>
                    <a:bodyPr lIns="137160" rIns="1371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 binding, anti-V2 mAb reactivity, and V2 immunogenic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sence of motif, evidence of binding, immune recognition of epitop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7160" rIns="1371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commend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37160" marR="137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1"/>
          <p:cNvSpPr/>
          <p:nvPr/>
        </p:nvSpPr>
        <p:spPr>
          <a:xfrm>
            <a:off x="152280" y="103320"/>
            <a:ext cx="868680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upplementary Table S1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2T14:58:51Z</dcterms:created>
  <dc:creator>deyan3</dc:creator>
  <dc:description/>
  <dc:language>en-US</dc:language>
  <cp:lastModifiedBy>Carlo</cp:lastModifiedBy>
  <cp:lastPrinted>2015-01-02T11:46:15Z</cp:lastPrinted>
  <dcterms:modified xsi:type="dcterms:W3CDTF">2016-04-18T22:01:53Z</dcterms:modified>
  <cp:revision>183</cp:revision>
  <dc:subject/>
  <dc:title>Slide 1</dc:title>
</cp:coreProperties>
</file>